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5898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4E1FF"/>
    <a:srgbClr val="FF7E79"/>
    <a:srgbClr val="0096FF"/>
    <a:srgbClr val="0432FF"/>
    <a:srgbClr val="008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366"/>
    <p:restoredTop sz="96197"/>
  </p:normalViewPr>
  <p:slideViewPr>
    <p:cSldViewPr snapToGrid="0" snapToObjects="1">
      <p:cViewPr varScale="1">
        <p:scale>
          <a:sx n="81" d="100"/>
          <a:sy n="81" d="100"/>
        </p:scale>
        <p:origin x="2792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547F076-C8C0-A741-9885-91F48CDCB025}" type="datetimeFigureOut">
              <a:rPr lang="en-US" smtClean="0"/>
              <a:t>2/24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340C79E-263A-6D45-9FCA-DF56B33AC5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39077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40595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00658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3179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38892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74926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59626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97582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51057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6568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06261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41963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04873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5" name="Picture 134">
            <a:extLst>
              <a:ext uri="{FF2B5EF4-FFF2-40B4-BE49-F238E27FC236}">
                <a16:creationId xmlns:a16="http://schemas.microsoft.com/office/drawing/2014/main" id="{7C13723D-7B73-339E-D771-428747E64E5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9696" y="1621746"/>
            <a:ext cx="619955" cy="568622"/>
          </a:xfrm>
          <a:prstGeom prst="rect">
            <a:avLst/>
          </a:prstGeom>
        </p:spPr>
      </p:pic>
      <p:pic>
        <p:nvPicPr>
          <p:cNvPr id="136" name="Picture 135">
            <a:extLst>
              <a:ext uri="{FF2B5EF4-FFF2-40B4-BE49-F238E27FC236}">
                <a16:creationId xmlns:a16="http://schemas.microsoft.com/office/drawing/2014/main" id="{6B379C6D-C700-3B3C-2AA6-121CE8B8D71E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33" t="26554" r="74295" b="56266"/>
          <a:stretch/>
        </p:blipFill>
        <p:spPr>
          <a:xfrm>
            <a:off x="2438937" y="1768818"/>
            <a:ext cx="648798" cy="498224"/>
          </a:xfrm>
          <a:prstGeom prst="rect">
            <a:avLst/>
          </a:prstGeom>
        </p:spPr>
      </p:pic>
      <p:sp>
        <p:nvSpPr>
          <p:cNvPr id="137" name="Lightning Bolt 136">
            <a:extLst>
              <a:ext uri="{FF2B5EF4-FFF2-40B4-BE49-F238E27FC236}">
                <a16:creationId xmlns:a16="http://schemas.microsoft.com/office/drawing/2014/main" id="{0ED82B3C-4DAC-1D8E-77D2-AA61F4008078}"/>
              </a:ext>
            </a:extLst>
          </p:cNvPr>
          <p:cNvSpPr/>
          <p:nvPr/>
        </p:nvSpPr>
        <p:spPr>
          <a:xfrm flipH="1">
            <a:off x="2977630" y="1716928"/>
            <a:ext cx="185018" cy="341879"/>
          </a:xfrm>
          <a:prstGeom prst="lightningBolt">
            <a:avLst/>
          </a:prstGeom>
          <a:solidFill>
            <a:srgbClr val="FFC000"/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75" dirty="0"/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6E8FAB36-0B09-6B6A-BF4F-FB013F5A9058}"/>
              </a:ext>
            </a:extLst>
          </p:cNvPr>
          <p:cNvSpPr txBox="1"/>
          <p:nvPr/>
        </p:nvSpPr>
        <p:spPr>
          <a:xfrm>
            <a:off x="3166469" y="1698377"/>
            <a:ext cx="1357394" cy="8771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75" dirty="0"/>
              <a:t>Ischemic reperfusion</a:t>
            </a:r>
          </a:p>
          <a:p>
            <a:r>
              <a:rPr lang="en-US" sz="1275" b="1" dirty="0"/>
              <a:t>Injured kidney</a:t>
            </a:r>
          </a:p>
          <a:p>
            <a:r>
              <a:rPr lang="en-US" sz="1275" dirty="0"/>
              <a:t>n=4</a:t>
            </a: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44EFA357-0830-5575-D784-F68E97994668}"/>
              </a:ext>
            </a:extLst>
          </p:cNvPr>
          <p:cNvSpPr txBox="1"/>
          <p:nvPr/>
        </p:nvSpPr>
        <p:spPr>
          <a:xfrm>
            <a:off x="1068237" y="1712142"/>
            <a:ext cx="1357394" cy="8771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75" dirty="0"/>
              <a:t>Contralateral kidney</a:t>
            </a:r>
          </a:p>
          <a:p>
            <a:pPr algn="r"/>
            <a:r>
              <a:rPr lang="en-US" sz="1275" b="1" dirty="0"/>
              <a:t>Control kidney</a:t>
            </a:r>
          </a:p>
          <a:p>
            <a:pPr algn="r"/>
            <a:r>
              <a:rPr lang="en-US" sz="1275" dirty="0"/>
              <a:t>n=4</a:t>
            </a:r>
          </a:p>
        </p:txBody>
      </p:sp>
      <p:cxnSp>
        <p:nvCxnSpPr>
          <p:cNvPr id="140" name="Straight Connector 139">
            <a:extLst>
              <a:ext uri="{FF2B5EF4-FFF2-40B4-BE49-F238E27FC236}">
                <a16:creationId xmlns:a16="http://schemas.microsoft.com/office/drawing/2014/main" id="{E92F7BA0-328C-6CE7-60A2-40062553D1EB}"/>
              </a:ext>
            </a:extLst>
          </p:cNvPr>
          <p:cNvCxnSpPr/>
          <p:nvPr/>
        </p:nvCxnSpPr>
        <p:spPr>
          <a:xfrm>
            <a:off x="2762228" y="1783773"/>
            <a:ext cx="1" cy="519383"/>
          </a:xfrm>
          <a:prstGeom prst="line">
            <a:avLst/>
          </a:prstGeom>
          <a:ln w="12700"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41" name="Picture 140">
            <a:extLst>
              <a:ext uri="{FF2B5EF4-FFF2-40B4-BE49-F238E27FC236}">
                <a16:creationId xmlns:a16="http://schemas.microsoft.com/office/drawing/2014/main" id="{E5478F05-B9A9-DCE7-B5BC-8A2F53AEF6C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7692" t="87068" r="29985" b="951"/>
          <a:stretch/>
        </p:blipFill>
        <p:spPr>
          <a:xfrm rot="10800000">
            <a:off x="383173" y="3879018"/>
            <a:ext cx="1018610" cy="671092"/>
          </a:xfrm>
          <a:prstGeom prst="rect">
            <a:avLst/>
          </a:prstGeom>
          <a:ln>
            <a:noFill/>
          </a:ln>
        </p:spPr>
      </p:pic>
      <p:sp>
        <p:nvSpPr>
          <p:cNvPr id="142" name="Rectangle 141">
            <a:extLst>
              <a:ext uri="{FF2B5EF4-FFF2-40B4-BE49-F238E27FC236}">
                <a16:creationId xmlns:a16="http://schemas.microsoft.com/office/drawing/2014/main" id="{4B148A33-983B-9240-8ADA-FE83D6BD0B60}"/>
              </a:ext>
            </a:extLst>
          </p:cNvPr>
          <p:cNvSpPr/>
          <p:nvPr/>
        </p:nvSpPr>
        <p:spPr>
          <a:xfrm rot="16200000">
            <a:off x="2337909" y="453899"/>
            <a:ext cx="946499" cy="337045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75"/>
          </a:p>
        </p:txBody>
      </p:sp>
      <p:cxnSp>
        <p:nvCxnSpPr>
          <p:cNvPr id="143" name="Straight Arrow Connector 142">
            <a:extLst>
              <a:ext uri="{FF2B5EF4-FFF2-40B4-BE49-F238E27FC236}">
                <a16:creationId xmlns:a16="http://schemas.microsoft.com/office/drawing/2014/main" id="{F49A45C7-4F1F-936E-D4BC-D576793E46D4}"/>
              </a:ext>
            </a:extLst>
          </p:cNvPr>
          <p:cNvCxnSpPr/>
          <p:nvPr/>
        </p:nvCxnSpPr>
        <p:spPr>
          <a:xfrm flipV="1">
            <a:off x="4545479" y="2042101"/>
            <a:ext cx="297092" cy="2852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4" name="TextBox 143">
            <a:extLst>
              <a:ext uri="{FF2B5EF4-FFF2-40B4-BE49-F238E27FC236}">
                <a16:creationId xmlns:a16="http://schemas.microsoft.com/office/drawing/2014/main" id="{4C70B5A6-4547-DD4C-5CD5-6DA7DECD2731}"/>
              </a:ext>
            </a:extLst>
          </p:cNvPr>
          <p:cNvSpPr txBox="1"/>
          <p:nvPr/>
        </p:nvSpPr>
        <p:spPr>
          <a:xfrm>
            <a:off x="4781338" y="1333941"/>
            <a:ext cx="2986983" cy="3277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30" b="1" dirty="0"/>
              <a:t>Tissue lysis and protein digestion</a:t>
            </a: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FA0D2BA3-9C26-79FB-076A-A602B1684587}"/>
              </a:ext>
            </a:extLst>
          </p:cNvPr>
          <p:cNvSpPr txBox="1"/>
          <p:nvPr/>
        </p:nvSpPr>
        <p:spPr>
          <a:xfrm>
            <a:off x="6295738" y="2169842"/>
            <a:ext cx="1481370" cy="4847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75" dirty="0">
                <a:solidFill>
                  <a:schemeClr val="tx1">
                    <a:lumMod val="75000"/>
                    <a:lumOff val="25000"/>
                  </a:schemeClr>
                </a:solidFill>
              </a:rPr>
              <a:t>whole lysate peptides</a:t>
            </a:r>
          </a:p>
        </p:txBody>
      </p:sp>
      <p:grpSp>
        <p:nvGrpSpPr>
          <p:cNvPr id="146" name="Group 145">
            <a:extLst>
              <a:ext uri="{FF2B5EF4-FFF2-40B4-BE49-F238E27FC236}">
                <a16:creationId xmlns:a16="http://schemas.microsoft.com/office/drawing/2014/main" id="{111A690E-48E2-8743-1C99-20CD6EFD88F5}"/>
              </a:ext>
            </a:extLst>
          </p:cNvPr>
          <p:cNvGrpSpPr/>
          <p:nvPr/>
        </p:nvGrpSpPr>
        <p:grpSpPr>
          <a:xfrm>
            <a:off x="6720308" y="1746062"/>
            <a:ext cx="551221" cy="422743"/>
            <a:chOff x="4536109" y="4349077"/>
            <a:chExt cx="688311" cy="388006"/>
          </a:xfrm>
        </p:grpSpPr>
        <p:grpSp>
          <p:nvGrpSpPr>
            <p:cNvPr id="147" name="Group 146">
              <a:extLst>
                <a:ext uri="{FF2B5EF4-FFF2-40B4-BE49-F238E27FC236}">
                  <a16:creationId xmlns:a16="http://schemas.microsoft.com/office/drawing/2014/main" id="{F151F878-0A29-5AA9-5236-FC0F398ADC74}"/>
                </a:ext>
              </a:extLst>
            </p:cNvPr>
            <p:cNvGrpSpPr/>
            <p:nvPr/>
          </p:nvGrpSpPr>
          <p:grpSpPr>
            <a:xfrm>
              <a:off x="4707130" y="4349077"/>
              <a:ext cx="418742" cy="253650"/>
              <a:chOff x="2358639" y="4621247"/>
              <a:chExt cx="418742" cy="253650"/>
            </a:xfrm>
          </p:grpSpPr>
          <p:sp>
            <p:nvSpPr>
              <p:cNvPr id="152" name="Freeform: Shape 132">
                <a:extLst>
                  <a:ext uri="{FF2B5EF4-FFF2-40B4-BE49-F238E27FC236}">
                    <a16:creationId xmlns:a16="http://schemas.microsoft.com/office/drawing/2014/main" id="{31DF4212-7818-F59B-27ED-30C01B65FE55}"/>
                  </a:ext>
                </a:extLst>
              </p:cNvPr>
              <p:cNvSpPr/>
              <p:nvPr/>
            </p:nvSpPr>
            <p:spPr>
              <a:xfrm rot="895257">
                <a:off x="2358639" y="4621247"/>
                <a:ext cx="259881" cy="216603"/>
              </a:xfrm>
              <a:custGeom>
                <a:avLst/>
                <a:gdLst>
                  <a:gd name="connsiteX0" fmla="*/ 0 w 190500"/>
                  <a:gd name="connsiteY0" fmla="*/ 0 h 158776"/>
                  <a:gd name="connsiteX1" fmla="*/ 38100 w 190500"/>
                  <a:gd name="connsiteY1" fmla="*/ 158750 h 158776"/>
                  <a:gd name="connsiteX2" fmla="*/ 127000 w 190500"/>
                  <a:gd name="connsiteY2" fmla="*/ 12700 h 158776"/>
                  <a:gd name="connsiteX3" fmla="*/ 165100 w 190500"/>
                  <a:gd name="connsiteY3" fmla="*/ 12700 h 158776"/>
                  <a:gd name="connsiteX4" fmla="*/ 190500 w 190500"/>
                  <a:gd name="connsiteY4" fmla="*/ 57150 h 15877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90500" h="158776">
                    <a:moveTo>
                      <a:pt x="0" y="0"/>
                    </a:moveTo>
                    <a:cubicBezTo>
                      <a:pt x="8466" y="78316"/>
                      <a:pt x="16933" y="156633"/>
                      <a:pt x="38100" y="158750"/>
                    </a:cubicBezTo>
                    <a:cubicBezTo>
                      <a:pt x="59267" y="160867"/>
                      <a:pt x="105833" y="37042"/>
                      <a:pt x="127000" y="12700"/>
                    </a:cubicBezTo>
                    <a:cubicBezTo>
                      <a:pt x="148167" y="-11642"/>
                      <a:pt x="154517" y="5292"/>
                      <a:pt x="165100" y="12700"/>
                    </a:cubicBezTo>
                    <a:cubicBezTo>
                      <a:pt x="175683" y="20108"/>
                      <a:pt x="183091" y="38629"/>
                      <a:pt x="190500" y="57150"/>
                    </a:cubicBez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75" dirty="0"/>
              </a:p>
            </p:txBody>
          </p:sp>
          <p:sp>
            <p:nvSpPr>
              <p:cNvPr id="153" name="Freeform: Shape 133">
                <a:extLst>
                  <a:ext uri="{FF2B5EF4-FFF2-40B4-BE49-F238E27FC236}">
                    <a16:creationId xmlns:a16="http://schemas.microsoft.com/office/drawing/2014/main" id="{8E0CA1FF-C4EF-DA45-BECB-CA93230EFADC}"/>
                  </a:ext>
                </a:extLst>
              </p:cNvPr>
              <p:cNvSpPr/>
              <p:nvPr/>
            </p:nvSpPr>
            <p:spPr>
              <a:xfrm rot="21443917">
                <a:off x="2517500" y="4658294"/>
                <a:ext cx="259881" cy="216603"/>
              </a:xfrm>
              <a:custGeom>
                <a:avLst/>
                <a:gdLst>
                  <a:gd name="connsiteX0" fmla="*/ 0 w 190500"/>
                  <a:gd name="connsiteY0" fmla="*/ 0 h 158776"/>
                  <a:gd name="connsiteX1" fmla="*/ 38100 w 190500"/>
                  <a:gd name="connsiteY1" fmla="*/ 158750 h 158776"/>
                  <a:gd name="connsiteX2" fmla="*/ 127000 w 190500"/>
                  <a:gd name="connsiteY2" fmla="*/ 12700 h 158776"/>
                  <a:gd name="connsiteX3" fmla="*/ 165100 w 190500"/>
                  <a:gd name="connsiteY3" fmla="*/ 12700 h 158776"/>
                  <a:gd name="connsiteX4" fmla="*/ 190500 w 190500"/>
                  <a:gd name="connsiteY4" fmla="*/ 57150 h 15877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90500" h="158776">
                    <a:moveTo>
                      <a:pt x="0" y="0"/>
                    </a:moveTo>
                    <a:cubicBezTo>
                      <a:pt x="8466" y="78316"/>
                      <a:pt x="16933" y="156633"/>
                      <a:pt x="38100" y="158750"/>
                    </a:cubicBezTo>
                    <a:cubicBezTo>
                      <a:pt x="59267" y="160867"/>
                      <a:pt x="105833" y="37042"/>
                      <a:pt x="127000" y="12700"/>
                    </a:cubicBezTo>
                    <a:cubicBezTo>
                      <a:pt x="148167" y="-11642"/>
                      <a:pt x="154517" y="5292"/>
                      <a:pt x="165100" y="12700"/>
                    </a:cubicBezTo>
                    <a:cubicBezTo>
                      <a:pt x="175683" y="20108"/>
                      <a:pt x="183091" y="38629"/>
                      <a:pt x="190500" y="57150"/>
                    </a:cubicBez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75" dirty="0"/>
              </a:p>
            </p:txBody>
          </p:sp>
        </p:grpSp>
        <p:grpSp>
          <p:nvGrpSpPr>
            <p:cNvPr id="148" name="Group 147">
              <a:extLst>
                <a:ext uri="{FF2B5EF4-FFF2-40B4-BE49-F238E27FC236}">
                  <a16:creationId xmlns:a16="http://schemas.microsoft.com/office/drawing/2014/main" id="{A3C57DCB-6F23-E6B0-ED44-1831A9D5F622}"/>
                </a:ext>
              </a:extLst>
            </p:cNvPr>
            <p:cNvGrpSpPr/>
            <p:nvPr/>
          </p:nvGrpSpPr>
          <p:grpSpPr>
            <a:xfrm>
              <a:off x="4536109" y="4459632"/>
              <a:ext cx="508260" cy="277451"/>
              <a:chOff x="2517500" y="4658294"/>
              <a:chExt cx="508260" cy="277451"/>
            </a:xfrm>
          </p:grpSpPr>
          <p:sp>
            <p:nvSpPr>
              <p:cNvPr id="150" name="Freeform: Shape 130">
                <a:extLst>
                  <a:ext uri="{FF2B5EF4-FFF2-40B4-BE49-F238E27FC236}">
                    <a16:creationId xmlns:a16="http://schemas.microsoft.com/office/drawing/2014/main" id="{A3999E61-6EF9-4B28-57C9-BE742595847E}"/>
                  </a:ext>
                </a:extLst>
              </p:cNvPr>
              <p:cNvSpPr/>
              <p:nvPr/>
            </p:nvSpPr>
            <p:spPr>
              <a:xfrm rot="20320005" flipV="1">
                <a:off x="2765879" y="4719142"/>
                <a:ext cx="259881" cy="216603"/>
              </a:xfrm>
              <a:custGeom>
                <a:avLst/>
                <a:gdLst>
                  <a:gd name="connsiteX0" fmla="*/ 0 w 190500"/>
                  <a:gd name="connsiteY0" fmla="*/ 0 h 158776"/>
                  <a:gd name="connsiteX1" fmla="*/ 38100 w 190500"/>
                  <a:gd name="connsiteY1" fmla="*/ 158750 h 158776"/>
                  <a:gd name="connsiteX2" fmla="*/ 127000 w 190500"/>
                  <a:gd name="connsiteY2" fmla="*/ 12700 h 158776"/>
                  <a:gd name="connsiteX3" fmla="*/ 165100 w 190500"/>
                  <a:gd name="connsiteY3" fmla="*/ 12700 h 158776"/>
                  <a:gd name="connsiteX4" fmla="*/ 190500 w 190500"/>
                  <a:gd name="connsiteY4" fmla="*/ 57150 h 15877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90500" h="158776">
                    <a:moveTo>
                      <a:pt x="0" y="0"/>
                    </a:moveTo>
                    <a:cubicBezTo>
                      <a:pt x="8466" y="78316"/>
                      <a:pt x="16933" y="156633"/>
                      <a:pt x="38100" y="158750"/>
                    </a:cubicBezTo>
                    <a:cubicBezTo>
                      <a:pt x="59267" y="160867"/>
                      <a:pt x="105833" y="37042"/>
                      <a:pt x="127000" y="12700"/>
                    </a:cubicBezTo>
                    <a:cubicBezTo>
                      <a:pt x="148167" y="-11642"/>
                      <a:pt x="154517" y="5292"/>
                      <a:pt x="165100" y="12700"/>
                    </a:cubicBezTo>
                    <a:cubicBezTo>
                      <a:pt x="175683" y="20108"/>
                      <a:pt x="183091" y="38629"/>
                      <a:pt x="190500" y="57150"/>
                    </a:cubicBez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75" dirty="0"/>
              </a:p>
            </p:txBody>
          </p:sp>
          <p:sp>
            <p:nvSpPr>
              <p:cNvPr id="151" name="Freeform: Shape 131">
                <a:extLst>
                  <a:ext uri="{FF2B5EF4-FFF2-40B4-BE49-F238E27FC236}">
                    <a16:creationId xmlns:a16="http://schemas.microsoft.com/office/drawing/2014/main" id="{987A9A4E-66C1-B9FE-5803-4BD64886DDDC}"/>
                  </a:ext>
                </a:extLst>
              </p:cNvPr>
              <p:cNvSpPr/>
              <p:nvPr/>
            </p:nvSpPr>
            <p:spPr>
              <a:xfrm rot="21443917">
                <a:off x="2517500" y="4658294"/>
                <a:ext cx="259881" cy="216603"/>
              </a:xfrm>
              <a:custGeom>
                <a:avLst/>
                <a:gdLst>
                  <a:gd name="connsiteX0" fmla="*/ 0 w 190500"/>
                  <a:gd name="connsiteY0" fmla="*/ 0 h 158776"/>
                  <a:gd name="connsiteX1" fmla="*/ 38100 w 190500"/>
                  <a:gd name="connsiteY1" fmla="*/ 158750 h 158776"/>
                  <a:gd name="connsiteX2" fmla="*/ 127000 w 190500"/>
                  <a:gd name="connsiteY2" fmla="*/ 12700 h 158776"/>
                  <a:gd name="connsiteX3" fmla="*/ 165100 w 190500"/>
                  <a:gd name="connsiteY3" fmla="*/ 12700 h 158776"/>
                  <a:gd name="connsiteX4" fmla="*/ 190500 w 190500"/>
                  <a:gd name="connsiteY4" fmla="*/ 57150 h 15877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90500" h="158776">
                    <a:moveTo>
                      <a:pt x="0" y="0"/>
                    </a:moveTo>
                    <a:cubicBezTo>
                      <a:pt x="8466" y="78316"/>
                      <a:pt x="16933" y="156633"/>
                      <a:pt x="38100" y="158750"/>
                    </a:cubicBezTo>
                    <a:cubicBezTo>
                      <a:pt x="59267" y="160867"/>
                      <a:pt x="105833" y="37042"/>
                      <a:pt x="127000" y="12700"/>
                    </a:cubicBezTo>
                    <a:cubicBezTo>
                      <a:pt x="148167" y="-11642"/>
                      <a:pt x="154517" y="5292"/>
                      <a:pt x="165100" y="12700"/>
                    </a:cubicBezTo>
                    <a:cubicBezTo>
                      <a:pt x="175683" y="20108"/>
                      <a:pt x="183091" y="38629"/>
                      <a:pt x="190500" y="57150"/>
                    </a:cubicBez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75" dirty="0"/>
              </a:p>
            </p:txBody>
          </p:sp>
        </p:grpSp>
        <p:sp>
          <p:nvSpPr>
            <p:cNvPr id="149" name="Freeform: Shape 129">
              <a:extLst>
                <a:ext uri="{FF2B5EF4-FFF2-40B4-BE49-F238E27FC236}">
                  <a16:creationId xmlns:a16="http://schemas.microsoft.com/office/drawing/2014/main" id="{1784BD79-9923-8B52-8276-E58BBFBD52CE}"/>
                </a:ext>
              </a:extLst>
            </p:cNvPr>
            <p:cNvSpPr/>
            <p:nvPr/>
          </p:nvSpPr>
          <p:spPr>
            <a:xfrm rot="156083" flipH="1">
              <a:off x="4964539" y="4477683"/>
              <a:ext cx="259881" cy="216603"/>
            </a:xfrm>
            <a:custGeom>
              <a:avLst/>
              <a:gdLst>
                <a:gd name="connsiteX0" fmla="*/ 0 w 190500"/>
                <a:gd name="connsiteY0" fmla="*/ 0 h 158776"/>
                <a:gd name="connsiteX1" fmla="*/ 38100 w 190500"/>
                <a:gd name="connsiteY1" fmla="*/ 158750 h 158776"/>
                <a:gd name="connsiteX2" fmla="*/ 127000 w 190500"/>
                <a:gd name="connsiteY2" fmla="*/ 12700 h 158776"/>
                <a:gd name="connsiteX3" fmla="*/ 165100 w 190500"/>
                <a:gd name="connsiteY3" fmla="*/ 12700 h 158776"/>
                <a:gd name="connsiteX4" fmla="*/ 190500 w 190500"/>
                <a:gd name="connsiteY4" fmla="*/ 57150 h 15877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90500" h="158776">
                  <a:moveTo>
                    <a:pt x="0" y="0"/>
                  </a:moveTo>
                  <a:cubicBezTo>
                    <a:pt x="8466" y="78316"/>
                    <a:pt x="16933" y="156633"/>
                    <a:pt x="38100" y="158750"/>
                  </a:cubicBezTo>
                  <a:cubicBezTo>
                    <a:pt x="59267" y="160867"/>
                    <a:pt x="105833" y="37042"/>
                    <a:pt x="127000" y="12700"/>
                  </a:cubicBezTo>
                  <a:cubicBezTo>
                    <a:pt x="148167" y="-11642"/>
                    <a:pt x="154517" y="5292"/>
                    <a:pt x="165100" y="12700"/>
                  </a:cubicBezTo>
                  <a:cubicBezTo>
                    <a:pt x="175683" y="20108"/>
                    <a:pt x="183091" y="38629"/>
                    <a:pt x="190500" y="57150"/>
                  </a:cubicBezTo>
                </a:path>
              </a:pathLst>
            </a:cu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75" dirty="0"/>
            </a:p>
          </p:txBody>
        </p:sp>
      </p:grpSp>
      <p:sp>
        <p:nvSpPr>
          <p:cNvPr id="154" name="TextBox 153">
            <a:extLst>
              <a:ext uri="{FF2B5EF4-FFF2-40B4-BE49-F238E27FC236}">
                <a16:creationId xmlns:a16="http://schemas.microsoft.com/office/drawing/2014/main" id="{BC3659F2-CA21-9193-D926-830D312FBB75}"/>
              </a:ext>
            </a:extLst>
          </p:cNvPr>
          <p:cNvSpPr txBox="1"/>
          <p:nvPr/>
        </p:nvSpPr>
        <p:spPr>
          <a:xfrm>
            <a:off x="281806" y="4550110"/>
            <a:ext cx="1181735" cy="6026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75" dirty="0"/>
              <a:t>Bioinformatics</a:t>
            </a:r>
          </a:p>
          <a:p>
            <a:pPr algn="ctr"/>
            <a:r>
              <a:rPr lang="en-US" sz="1148" dirty="0"/>
              <a:t>Protein Groups </a:t>
            </a:r>
          </a:p>
          <a:p>
            <a:pPr algn="ctr"/>
            <a:r>
              <a:rPr lang="en-US" sz="893" dirty="0"/>
              <a:t>(≥ 2 unique peptides)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8AF22434-B34C-B071-8C8D-C3F35021D3C5}"/>
              </a:ext>
            </a:extLst>
          </p:cNvPr>
          <p:cNvSpPr txBox="1"/>
          <p:nvPr/>
        </p:nvSpPr>
        <p:spPr>
          <a:xfrm>
            <a:off x="2542231" y="2691873"/>
            <a:ext cx="1242777" cy="6809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75" b="1" dirty="0">
                <a:solidFill>
                  <a:srgbClr val="0432FF"/>
                </a:solidFill>
              </a:rPr>
              <a:t>DDA generated </a:t>
            </a:r>
          </a:p>
          <a:p>
            <a:pPr algn="ctr"/>
            <a:r>
              <a:rPr lang="en-US" sz="1275" b="1" dirty="0">
                <a:solidFill>
                  <a:srgbClr val="0432FF"/>
                </a:solidFill>
              </a:rPr>
              <a:t>deep</a:t>
            </a:r>
          </a:p>
          <a:p>
            <a:pPr algn="ctr"/>
            <a:r>
              <a:rPr lang="en-US" sz="1275" b="1" dirty="0">
                <a:solidFill>
                  <a:srgbClr val="0432FF"/>
                </a:solidFill>
              </a:rPr>
              <a:t>spectral library</a:t>
            </a:r>
          </a:p>
        </p:txBody>
      </p:sp>
      <p:cxnSp>
        <p:nvCxnSpPr>
          <p:cNvPr id="156" name="Straight Arrow Connector 155">
            <a:extLst>
              <a:ext uri="{FF2B5EF4-FFF2-40B4-BE49-F238E27FC236}">
                <a16:creationId xmlns:a16="http://schemas.microsoft.com/office/drawing/2014/main" id="{1CECADBE-2424-E859-EF0C-B610BF723F65}"/>
              </a:ext>
            </a:extLst>
          </p:cNvPr>
          <p:cNvCxnSpPr>
            <a:cxnSpLocks/>
          </p:cNvCxnSpPr>
          <p:nvPr/>
        </p:nvCxnSpPr>
        <p:spPr>
          <a:xfrm>
            <a:off x="6544369" y="2635297"/>
            <a:ext cx="1" cy="202571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7" name="Left Brace 156">
            <a:extLst>
              <a:ext uri="{FF2B5EF4-FFF2-40B4-BE49-F238E27FC236}">
                <a16:creationId xmlns:a16="http://schemas.microsoft.com/office/drawing/2014/main" id="{0A9DA592-A63E-CB76-DD0A-2B61AF68EBC4}"/>
              </a:ext>
            </a:extLst>
          </p:cNvPr>
          <p:cNvSpPr/>
          <p:nvPr/>
        </p:nvSpPr>
        <p:spPr>
          <a:xfrm>
            <a:off x="1726117" y="2765824"/>
            <a:ext cx="229233" cy="2361065"/>
          </a:xfrm>
          <a:prstGeom prst="leftBrac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275"/>
          </a:p>
        </p:txBody>
      </p:sp>
      <p:sp>
        <p:nvSpPr>
          <p:cNvPr id="158" name="Cloud 157">
            <a:extLst>
              <a:ext uri="{FF2B5EF4-FFF2-40B4-BE49-F238E27FC236}">
                <a16:creationId xmlns:a16="http://schemas.microsoft.com/office/drawing/2014/main" id="{8B403D3B-C245-BC4A-CF72-5F86478560E2}"/>
              </a:ext>
            </a:extLst>
          </p:cNvPr>
          <p:cNvSpPr/>
          <p:nvPr/>
        </p:nvSpPr>
        <p:spPr>
          <a:xfrm>
            <a:off x="251298" y="2776569"/>
            <a:ext cx="1231994" cy="998004"/>
          </a:xfrm>
          <a:prstGeom prst="cloud">
            <a:avLst/>
          </a:prstGeom>
          <a:noFill/>
          <a:ln w="12700"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75"/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6CA569F7-7666-4159-3CA1-87B4591AC348}"/>
              </a:ext>
            </a:extLst>
          </p:cNvPr>
          <p:cNvSpPr txBox="1"/>
          <p:nvPr/>
        </p:nvSpPr>
        <p:spPr>
          <a:xfrm>
            <a:off x="332508" y="2822258"/>
            <a:ext cx="1046324" cy="8771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75" dirty="0"/>
              <a:t>Data Processing in Spectronaut v16</a:t>
            </a:r>
          </a:p>
        </p:txBody>
      </p:sp>
      <p:sp>
        <p:nvSpPr>
          <p:cNvPr id="160" name="Rectangle 159">
            <a:extLst>
              <a:ext uri="{FF2B5EF4-FFF2-40B4-BE49-F238E27FC236}">
                <a16:creationId xmlns:a16="http://schemas.microsoft.com/office/drawing/2014/main" id="{D55110C8-1B39-22C6-C5EB-03DDEEF339EC}"/>
              </a:ext>
            </a:extLst>
          </p:cNvPr>
          <p:cNvSpPr/>
          <p:nvPr/>
        </p:nvSpPr>
        <p:spPr>
          <a:xfrm rot="16200000">
            <a:off x="5778422" y="763628"/>
            <a:ext cx="949353" cy="275384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75"/>
          </a:p>
        </p:txBody>
      </p:sp>
      <p:sp>
        <p:nvSpPr>
          <p:cNvPr id="161" name="Freeform: Shape 59">
            <a:extLst>
              <a:ext uri="{FF2B5EF4-FFF2-40B4-BE49-F238E27FC236}">
                <a16:creationId xmlns:a16="http://schemas.microsoft.com/office/drawing/2014/main" id="{1C74B9F9-856B-293F-EA51-4406020D75EA}"/>
              </a:ext>
            </a:extLst>
          </p:cNvPr>
          <p:cNvSpPr/>
          <p:nvPr/>
        </p:nvSpPr>
        <p:spPr>
          <a:xfrm rot="1286858">
            <a:off x="5060349" y="1785761"/>
            <a:ext cx="415076" cy="343345"/>
          </a:xfrm>
          <a:custGeom>
            <a:avLst/>
            <a:gdLst>
              <a:gd name="connsiteX0" fmla="*/ 1960 w 211510"/>
              <a:gd name="connsiteY0" fmla="*/ 208609 h 297563"/>
              <a:gd name="connsiteX1" fmla="*/ 192460 w 211510"/>
              <a:gd name="connsiteY1" fmla="*/ 24459 h 297563"/>
              <a:gd name="connsiteX2" fmla="*/ 179760 w 211510"/>
              <a:gd name="connsiteY2" fmla="*/ 297509 h 297563"/>
              <a:gd name="connsiteX3" fmla="*/ 1960 w 211510"/>
              <a:gd name="connsiteY3" fmla="*/ 49859 h 297563"/>
              <a:gd name="connsiteX4" fmla="*/ 90860 w 211510"/>
              <a:gd name="connsiteY4" fmla="*/ 253059 h 297563"/>
              <a:gd name="connsiteX5" fmla="*/ 186110 w 211510"/>
              <a:gd name="connsiteY5" fmla="*/ 75259 h 297563"/>
              <a:gd name="connsiteX6" fmla="*/ 52760 w 211510"/>
              <a:gd name="connsiteY6" fmla="*/ 5409 h 297563"/>
              <a:gd name="connsiteX7" fmla="*/ 211510 w 211510"/>
              <a:gd name="connsiteY7" fmla="*/ 208609 h 29756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211510" h="297563">
                <a:moveTo>
                  <a:pt x="1960" y="208609"/>
                </a:moveTo>
                <a:cubicBezTo>
                  <a:pt x="82393" y="109125"/>
                  <a:pt x="162827" y="9642"/>
                  <a:pt x="192460" y="24459"/>
                </a:cubicBezTo>
                <a:cubicBezTo>
                  <a:pt x="222093" y="39276"/>
                  <a:pt x="211510" y="293276"/>
                  <a:pt x="179760" y="297509"/>
                </a:cubicBezTo>
                <a:cubicBezTo>
                  <a:pt x="148010" y="301742"/>
                  <a:pt x="16777" y="57267"/>
                  <a:pt x="1960" y="49859"/>
                </a:cubicBezTo>
                <a:cubicBezTo>
                  <a:pt x="-12857" y="42451"/>
                  <a:pt x="60168" y="248826"/>
                  <a:pt x="90860" y="253059"/>
                </a:cubicBezTo>
                <a:cubicBezTo>
                  <a:pt x="121552" y="257292"/>
                  <a:pt x="192460" y="116534"/>
                  <a:pt x="186110" y="75259"/>
                </a:cubicBezTo>
                <a:cubicBezTo>
                  <a:pt x="179760" y="33984"/>
                  <a:pt x="48527" y="-16816"/>
                  <a:pt x="52760" y="5409"/>
                </a:cubicBezTo>
                <a:cubicBezTo>
                  <a:pt x="56993" y="27634"/>
                  <a:pt x="173410" y="168392"/>
                  <a:pt x="211510" y="208609"/>
                </a:cubicBezTo>
              </a:path>
            </a:pathLst>
          </a:cu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75"/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7C8A6195-1E44-F615-C2FE-136CDF3392AA}"/>
              </a:ext>
            </a:extLst>
          </p:cNvPr>
          <p:cNvSpPr txBox="1"/>
          <p:nvPr/>
        </p:nvSpPr>
        <p:spPr>
          <a:xfrm>
            <a:off x="101068" y="2138228"/>
            <a:ext cx="896399" cy="2885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75" dirty="0"/>
              <a:t>WT mouse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5126D7C8-B531-E8C4-1807-34493B32D97F}"/>
              </a:ext>
            </a:extLst>
          </p:cNvPr>
          <p:cNvSpPr txBox="1"/>
          <p:nvPr/>
        </p:nvSpPr>
        <p:spPr>
          <a:xfrm>
            <a:off x="4955106" y="2164264"/>
            <a:ext cx="704916" cy="2885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75" dirty="0"/>
              <a:t>Protein</a:t>
            </a:r>
          </a:p>
        </p:txBody>
      </p:sp>
      <p:cxnSp>
        <p:nvCxnSpPr>
          <p:cNvPr id="164" name="Straight Arrow Connector 163">
            <a:extLst>
              <a:ext uri="{FF2B5EF4-FFF2-40B4-BE49-F238E27FC236}">
                <a16:creationId xmlns:a16="http://schemas.microsoft.com/office/drawing/2014/main" id="{5528BF12-3592-B99C-8406-8236A22D68B7}"/>
              </a:ext>
            </a:extLst>
          </p:cNvPr>
          <p:cNvCxnSpPr/>
          <p:nvPr/>
        </p:nvCxnSpPr>
        <p:spPr>
          <a:xfrm>
            <a:off x="5651392" y="1981996"/>
            <a:ext cx="904574" cy="0"/>
          </a:xfrm>
          <a:prstGeom prst="straightConnector1">
            <a:avLst/>
          </a:prstGeom>
          <a:ln>
            <a:solidFill>
              <a:schemeClr val="bg2">
                <a:lumMod val="25000"/>
              </a:schemeClr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5" name="TextBox 164">
            <a:extLst>
              <a:ext uri="{FF2B5EF4-FFF2-40B4-BE49-F238E27FC236}">
                <a16:creationId xmlns:a16="http://schemas.microsoft.com/office/drawing/2014/main" id="{B4E0C0BF-68B7-7775-3E04-E16B7A7DDD58}"/>
              </a:ext>
            </a:extLst>
          </p:cNvPr>
          <p:cNvSpPr txBox="1"/>
          <p:nvPr/>
        </p:nvSpPr>
        <p:spPr>
          <a:xfrm>
            <a:off x="5787467" y="1778060"/>
            <a:ext cx="636841" cy="2885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75" i="1" dirty="0"/>
              <a:t>trypsin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1A68DFC9-46A9-3268-7CAA-D01764A2BEB4}"/>
              </a:ext>
            </a:extLst>
          </p:cNvPr>
          <p:cNvSpPr txBox="1"/>
          <p:nvPr/>
        </p:nvSpPr>
        <p:spPr>
          <a:xfrm>
            <a:off x="1340597" y="1336338"/>
            <a:ext cx="2986983" cy="3277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530" b="1" dirty="0"/>
              <a:t>Tissue collection</a:t>
            </a:r>
          </a:p>
        </p:txBody>
      </p:sp>
      <p:cxnSp>
        <p:nvCxnSpPr>
          <p:cNvPr id="167" name="Straight Arrow Connector 166">
            <a:extLst>
              <a:ext uri="{FF2B5EF4-FFF2-40B4-BE49-F238E27FC236}">
                <a16:creationId xmlns:a16="http://schemas.microsoft.com/office/drawing/2014/main" id="{8D8237D4-1F60-6B7E-1168-0398EB15A677}"/>
              </a:ext>
            </a:extLst>
          </p:cNvPr>
          <p:cNvCxnSpPr/>
          <p:nvPr/>
        </p:nvCxnSpPr>
        <p:spPr>
          <a:xfrm flipV="1">
            <a:off x="779506" y="2042101"/>
            <a:ext cx="297092" cy="2852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8" name="TextBox 167">
            <a:extLst>
              <a:ext uri="{FF2B5EF4-FFF2-40B4-BE49-F238E27FC236}">
                <a16:creationId xmlns:a16="http://schemas.microsoft.com/office/drawing/2014/main" id="{8EC3E813-084E-0C69-5C8D-F4810472B349}"/>
              </a:ext>
            </a:extLst>
          </p:cNvPr>
          <p:cNvSpPr txBox="1"/>
          <p:nvPr/>
        </p:nvSpPr>
        <p:spPr>
          <a:xfrm>
            <a:off x="1548158" y="1028536"/>
            <a:ext cx="4874796" cy="3670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85" b="1" dirty="0"/>
              <a:t>Acute Kidney Injury (AKI) – Whole Lysate Analysis</a:t>
            </a:r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3C2F039C-3628-FDAD-2260-2E82D5E6C154}"/>
              </a:ext>
            </a:extLst>
          </p:cNvPr>
          <p:cNvSpPr txBox="1"/>
          <p:nvPr/>
        </p:nvSpPr>
        <p:spPr>
          <a:xfrm>
            <a:off x="5304768" y="3368068"/>
            <a:ext cx="836792" cy="4847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75" b="1" dirty="0"/>
              <a:t>400 ng</a:t>
            </a:r>
          </a:p>
          <a:p>
            <a:pPr algn="ctr"/>
            <a:r>
              <a:rPr lang="en-US" sz="1275" b="1" dirty="0"/>
              <a:t>20 min</a:t>
            </a:r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DDD2EA10-AE98-6965-B15C-5A843C441C3D}"/>
              </a:ext>
            </a:extLst>
          </p:cNvPr>
          <p:cNvSpPr txBox="1"/>
          <p:nvPr/>
        </p:nvSpPr>
        <p:spPr>
          <a:xfrm>
            <a:off x="5303067" y="2691762"/>
            <a:ext cx="821059" cy="6417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75" b="1" dirty="0"/>
              <a:t>1,000 ng</a:t>
            </a:r>
          </a:p>
          <a:p>
            <a:pPr algn="ctr"/>
            <a:r>
              <a:rPr lang="en-US" sz="1275" b="1" dirty="0"/>
              <a:t>120 min</a:t>
            </a:r>
            <a:endParaRPr lang="en-US" sz="1275" dirty="0"/>
          </a:p>
          <a:p>
            <a:pPr algn="ctr"/>
            <a:r>
              <a:rPr lang="en-US" sz="1020" dirty="0"/>
              <a:t>3 </a:t>
            </a:r>
            <a:r>
              <a:rPr lang="en-US" sz="1020" dirty="0" err="1"/>
              <a:t>techn</a:t>
            </a:r>
            <a:r>
              <a:rPr lang="en-US" sz="1020" dirty="0"/>
              <a:t> </a:t>
            </a:r>
            <a:r>
              <a:rPr lang="en-US" sz="1020" dirty="0" err="1"/>
              <a:t>repl</a:t>
            </a:r>
            <a:endParaRPr lang="en-US" sz="1020" dirty="0"/>
          </a:p>
        </p:txBody>
      </p:sp>
      <p:cxnSp>
        <p:nvCxnSpPr>
          <p:cNvPr id="171" name="Straight Connector 170">
            <a:extLst>
              <a:ext uri="{FF2B5EF4-FFF2-40B4-BE49-F238E27FC236}">
                <a16:creationId xmlns:a16="http://schemas.microsoft.com/office/drawing/2014/main" id="{72C78C2C-0310-B06C-C961-DF1C5051B87E}"/>
              </a:ext>
            </a:extLst>
          </p:cNvPr>
          <p:cNvCxnSpPr/>
          <p:nvPr/>
        </p:nvCxnSpPr>
        <p:spPr>
          <a:xfrm flipV="1">
            <a:off x="6860709" y="2873216"/>
            <a:ext cx="1" cy="1766032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2" name="TextBox 171">
            <a:extLst>
              <a:ext uri="{FF2B5EF4-FFF2-40B4-BE49-F238E27FC236}">
                <a16:creationId xmlns:a16="http://schemas.microsoft.com/office/drawing/2014/main" id="{9F5FA322-FF71-55E4-473D-F26AB636E29B}"/>
              </a:ext>
            </a:extLst>
          </p:cNvPr>
          <p:cNvSpPr txBox="1"/>
          <p:nvPr/>
        </p:nvSpPr>
        <p:spPr>
          <a:xfrm>
            <a:off x="6297485" y="2888804"/>
            <a:ext cx="622359" cy="4456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48" dirty="0" err="1"/>
              <a:t>n</a:t>
            </a:r>
            <a:r>
              <a:rPr lang="en-US" sz="1148" baseline="-25000" dirty="0" err="1"/>
              <a:t>con</a:t>
            </a:r>
            <a:r>
              <a:rPr lang="en-US" sz="1148" dirty="0"/>
              <a:t>= 4</a:t>
            </a:r>
          </a:p>
          <a:p>
            <a:r>
              <a:rPr lang="en-US" sz="1148" dirty="0" err="1"/>
              <a:t>n</a:t>
            </a:r>
            <a:r>
              <a:rPr lang="en-US" sz="1148" baseline="-25000" dirty="0" err="1"/>
              <a:t>Inj</a:t>
            </a:r>
            <a:r>
              <a:rPr lang="en-US" sz="1148" baseline="-25000" dirty="0"/>
              <a:t> </a:t>
            </a:r>
            <a:r>
              <a:rPr lang="en-US" sz="1148" dirty="0"/>
              <a:t>= 4</a:t>
            </a:r>
          </a:p>
        </p:txBody>
      </p:sp>
      <p:cxnSp>
        <p:nvCxnSpPr>
          <p:cNvPr id="173" name="Straight Connector 172">
            <a:extLst>
              <a:ext uri="{FF2B5EF4-FFF2-40B4-BE49-F238E27FC236}">
                <a16:creationId xmlns:a16="http://schemas.microsoft.com/office/drawing/2014/main" id="{810F803E-5060-1AA5-70A0-C68E6EB921E9}"/>
              </a:ext>
            </a:extLst>
          </p:cNvPr>
          <p:cNvCxnSpPr>
            <a:cxnSpLocks/>
          </p:cNvCxnSpPr>
          <p:nvPr/>
        </p:nvCxnSpPr>
        <p:spPr>
          <a:xfrm>
            <a:off x="6515959" y="3425226"/>
            <a:ext cx="353068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4" name="Straight Arrow Connector 173">
            <a:extLst>
              <a:ext uri="{FF2B5EF4-FFF2-40B4-BE49-F238E27FC236}">
                <a16:creationId xmlns:a16="http://schemas.microsoft.com/office/drawing/2014/main" id="{D229CF14-538A-7415-B9DE-06C25009A814}"/>
              </a:ext>
            </a:extLst>
          </p:cNvPr>
          <p:cNvCxnSpPr>
            <a:cxnSpLocks/>
          </p:cNvCxnSpPr>
          <p:nvPr/>
        </p:nvCxnSpPr>
        <p:spPr>
          <a:xfrm flipH="1">
            <a:off x="6234822" y="2875733"/>
            <a:ext cx="634255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5" name="Straight Arrow Connector 174">
            <a:extLst>
              <a:ext uri="{FF2B5EF4-FFF2-40B4-BE49-F238E27FC236}">
                <a16:creationId xmlns:a16="http://schemas.microsoft.com/office/drawing/2014/main" id="{0B0CE7CE-904C-0B43-5E51-EA5E7B841E61}"/>
              </a:ext>
            </a:extLst>
          </p:cNvPr>
          <p:cNvCxnSpPr/>
          <p:nvPr/>
        </p:nvCxnSpPr>
        <p:spPr>
          <a:xfrm flipH="1" flipV="1">
            <a:off x="6163177" y="3425226"/>
            <a:ext cx="371626" cy="142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6" name="Straight Arrow Connector 175">
            <a:extLst>
              <a:ext uri="{FF2B5EF4-FFF2-40B4-BE49-F238E27FC236}">
                <a16:creationId xmlns:a16="http://schemas.microsoft.com/office/drawing/2014/main" id="{703B9C3A-ADAE-C600-E387-8919A9270548}"/>
              </a:ext>
            </a:extLst>
          </p:cNvPr>
          <p:cNvCxnSpPr>
            <a:cxnSpLocks/>
          </p:cNvCxnSpPr>
          <p:nvPr/>
        </p:nvCxnSpPr>
        <p:spPr>
          <a:xfrm flipH="1" flipV="1">
            <a:off x="6156980" y="4638536"/>
            <a:ext cx="702817" cy="1568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7" name="Rectangle 176">
            <a:extLst>
              <a:ext uri="{FF2B5EF4-FFF2-40B4-BE49-F238E27FC236}">
                <a16:creationId xmlns:a16="http://schemas.microsoft.com/office/drawing/2014/main" id="{2803903B-BB18-E5DE-9CCA-ACD85E18E39D}"/>
              </a:ext>
            </a:extLst>
          </p:cNvPr>
          <p:cNvSpPr/>
          <p:nvPr/>
        </p:nvSpPr>
        <p:spPr>
          <a:xfrm>
            <a:off x="5311821" y="2674160"/>
            <a:ext cx="836792" cy="625846"/>
          </a:xfrm>
          <a:prstGeom prst="rect">
            <a:avLst/>
          </a:prstGeom>
          <a:noFill/>
          <a:ln w="38100">
            <a:solidFill>
              <a:srgbClr val="0432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>
              <a:solidFill>
                <a:srgbClr val="00B0F0"/>
              </a:solidFill>
            </a:endParaRPr>
          </a:p>
        </p:txBody>
      </p:sp>
      <p:sp>
        <p:nvSpPr>
          <p:cNvPr id="178" name="TextBox 177">
            <a:extLst>
              <a:ext uri="{FF2B5EF4-FFF2-40B4-BE49-F238E27FC236}">
                <a16:creationId xmlns:a16="http://schemas.microsoft.com/office/drawing/2014/main" id="{998076F3-5102-D7B0-9620-CF8CC6FCD411}"/>
              </a:ext>
            </a:extLst>
          </p:cNvPr>
          <p:cNvSpPr txBox="1"/>
          <p:nvPr/>
        </p:nvSpPr>
        <p:spPr>
          <a:xfrm>
            <a:off x="6300784" y="3444820"/>
            <a:ext cx="615761" cy="4456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48" dirty="0" err="1"/>
              <a:t>n</a:t>
            </a:r>
            <a:r>
              <a:rPr lang="en-US" sz="1148" baseline="-25000" dirty="0" err="1"/>
              <a:t>con</a:t>
            </a:r>
            <a:r>
              <a:rPr lang="en-US" sz="1148" dirty="0"/>
              <a:t>= 4</a:t>
            </a:r>
          </a:p>
          <a:p>
            <a:r>
              <a:rPr lang="en-US" sz="1148" dirty="0" err="1"/>
              <a:t>n</a:t>
            </a:r>
            <a:r>
              <a:rPr lang="en-US" sz="1148" baseline="-25000" dirty="0" err="1"/>
              <a:t>Inj</a:t>
            </a:r>
            <a:r>
              <a:rPr lang="en-US" sz="1148" baseline="-25000" dirty="0"/>
              <a:t> </a:t>
            </a:r>
            <a:r>
              <a:rPr lang="en-US" sz="1148" dirty="0"/>
              <a:t>= 4</a:t>
            </a:r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id="{A09C10F8-586E-8127-886B-85D7FC9DDA26}"/>
              </a:ext>
            </a:extLst>
          </p:cNvPr>
          <p:cNvSpPr txBox="1"/>
          <p:nvPr/>
        </p:nvSpPr>
        <p:spPr>
          <a:xfrm>
            <a:off x="5400697" y="3955828"/>
            <a:ext cx="649537" cy="4847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75" b="1" dirty="0"/>
              <a:t>400 ng</a:t>
            </a:r>
          </a:p>
          <a:p>
            <a:pPr algn="ctr"/>
            <a:r>
              <a:rPr lang="en-US" sz="1275" b="1" dirty="0"/>
              <a:t>45 min</a:t>
            </a:r>
            <a:endParaRPr lang="en-US" sz="1275" dirty="0"/>
          </a:p>
        </p:txBody>
      </p:sp>
      <p:cxnSp>
        <p:nvCxnSpPr>
          <p:cNvPr id="180" name="Straight Connector 179">
            <a:extLst>
              <a:ext uri="{FF2B5EF4-FFF2-40B4-BE49-F238E27FC236}">
                <a16:creationId xmlns:a16="http://schemas.microsoft.com/office/drawing/2014/main" id="{1DB608D3-5CB2-CD09-F48E-C9F3C41B5220}"/>
              </a:ext>
            </a:extLst>
          </p:cNvPr>
          <p:cNvCxnSpPr>
            <a:cxnSpLocks/>
          </p:cNvCxnSpPr>
          <p:nvPr/>
        </p:nvCxnSpPr>
        <p:spPr>
          <a:xfrm>
            <a:off x="6512073" y="4094480"/>
            <a:ext cx="356954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1" name="Straight Arrow Connector 180">
            <a:extLst>
              <a:ext uri="{FF2B5EF4-FFF2-40B4-BE49-F238E27FC236}">
                <a16:creationId xmlns:a16="http://schemas.microsoft.com/office/drawing/2014/main" id="{185298F7-1865-EA53-0D0C-1015B5289113}"/>
              </a:ext>
            </a:extLst>
          </p:cNvPr>
          <p:cNvCxnSpPr/>
          <p:nvPr/>
        </p:nvCxnSpPr>
        <p:spPr>
          <a:xfrm flipH="1" flipV="1">
            <a:off x="6159291" y="4094480"/>
            <a:ext cx="371626" cy="142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2" name="TextBox 181">
            <a:extLst>
              <a:ext uri="{FF2B5EF4-FFF2-40B4-BE49-F238E27FC236}">
                <a16:creationId xmlns:a16="http://schemas.microsoft.com/office/drawing/2014/main" id="{ACB0E9BF-B3CD-FB34-FC25-3F2FE3515F12}"/>
              </a:ext>
            </a:extLst>
          </p:cNvPr>
          <p:cNvSpPr txBox="1"/>
          <p:nvPr/>
        </p:nvSpPr>
        <p:spPr>
          <a:xfrm>
            <a:off x="6296341" y="4053785"/>
            <a:ext cx="615761" cy="4456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48" dirty="0" err="1"/>
              <a:t>n</a:t>
            </a:r>
            <a:r>
              <a:rPr lang="en-US" sz="1148" baseline="-25000" dirty="0" err="1"/>
              <a:t>con</a:t>
            </a:r>
            <a:r>
              <a:rPr lang="en-US" sz="1148" dirty="0"/>
              <a:t>= 4</a:t>
            </a:r>
          </a:p>
          <a:p>
            <a:r>
              <a:rPr lang="en-US" sz="1148" dirty="0" err="1"/>
              <a:t>n</a:t>
            </a:r>
            <a:r>
              <a:rPr lang="en-US" sz="1148" baseline="-25000" dirty="0" err="1"/>
              <a:t>Inj</a:t>
            </a:r>
            <a:r>
              <a:rPr lang="en-US" sz="1148" baseline="-25000" dirty="0"/>
              <a:t> </a:t>
            </a:r>
            <a:r>
              <a:rPr lang="en-US" sz="1148" dirty="0"/>
              <a:t>= 4</a:t>
            </a:r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CB814F67-9995-1453-CEA1-744D033AC599}"/>
              </a:ext>
            </a:extLst>
          </p:cNvPr>
          <p:cNvSpPr txBox="1"/>
          <p:nvPr/>
        </p:nvSpPr>
        <p:spPr>
          <a:xfrm>
            <a:off x="5340704" y="4583220"/>
            <a:ext cx="761748" cy="4847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75" b="1" dirty="0"/>
              <a:t>1,000 ng</a:t>
            </a:r>
          </a:p>
          <a:p>
            <a:pPr algn="ctr"/>
            <a:r>
              <a:rPr lang="en-US" sz="1275" b="1" dirty="0"/>
              <a:t>120 min</a:t>
            </a:r>
            <a:endParaRPr lang="en-US" sz="1275" dirty="0"/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560B4133-F8F1-B04F-A401-D86F3F6FFE77}"/>
              </a:ext>
            </a:extLst>
          </p:cNvPr>
          <p:cNvSpPr txBox="1"/>
          <p:nvPr/>
        </p:nvSpPr>
        <p:spPr>
          <a:xfrm>
            <a:off x="6294313" y="4650504"/>
            <a:ext cx="615761" cy="4456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48" dirty="0" err="1"/>
              <a:t>n</a:t>
            </a:r>
            <a:r>
              <a:rPr lang="en-US" sz="1148" baseline="-25000" dirty="0" err="1"/>
              <a:t>con</a:t>
            </a:r>
            <a:r>
              <a:rPr lang="en-US" sz="1148" dirty="0"/>
              <a:t>= 4</a:t>
            </a:r>
          </a:p>
          <a:p>
            <a:r>
              <a:rPr lang="en-US" sz="1148" dirty="0" err="1"/>
              <a:t>n</a:t>
            </a:r>
            <a:r>
              <a:rPr lang="en-US" sz="1148" baseline="-25000" dirty="0" err="1"/>
              <a:t>Inj</a:t>
            </a:r>
            <a:r>
              <a:rPr lang="en-US" sz="1148" baseline="-25000" dirty="0"/>
              <a:t> </a:t>
            </a:r>
            <a:r>
              <a:rPr lang="en-US" sz="1148" dirty="0"/>
              <a:t>= 4</a:t>
            </a:r>
          </a:p>
        </p:txBody>
      </p:sp>
      <p:sp>
        <p:nvSpPr>
          <p:cNvPr id="185" name="Rectangle 184">
            <a:extLst>
              <a:ext uri="{FF2B5EF4-FFF2-40B4-BE49-F238E27FC236}">
                <a16:creationId xmlns:a16="http://schemas.microsoft.com/office/drawing/2014/main" id="{4A444488-BAD9-6B71-771A-40E91F61DD3F}"/>
              </a:ext>
            </a:extLst>
          </p:cNvPr>
          <p:cNvSpPr/>
          <p:nvPr/>
        </p:nvSpPr>
        <p:spPr>
          <a:xfrm>
            <a:off x="5307985" y="3317608"/>
            <a:ext cx="836792" cy="1799369"/>
          </a:xfrm>
          <a:prstGeom prst="rect">
            <a:avLst/>
          </a:prstGeom>
          <a:noFill/>
          <a:ln w="38100">
            <a:solidFill>
              <a:srgbClr val="00905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>
              <a:solidFill>
                <a:srgbClr val="00B0F0"/>
              </a:solidFill>
            </a:endParaRPr>
          </a:p>
        </p:txBody>
      </p:sp>
      <p:cxnSp>
        <p:nvCxnSpPr>
          <p:cNvPr id="186" name="Straight Arrow Connector 185">
            <a:extLst>
              <a:ext uri="{FF2B5EF4-FFF2-40B4-BE49-F238E27FC236}">
                <a16:creationId xmlns:a16="http://schemas.microsoft.com/office/drawing/2014/main" id="{1BA16D29-6000-221F-E383-5796F6A223CD}"/>
              </a:ext>
            </a:extLst>
          </p:cNvPr>
          <p:cNvCxnSpPr>
            <a:cxnSpLocks/>
          </p:cNvCxnSpPr>
          <p:nvPr/>
        </p:nvCxnSpPr>
        <p:spPr>
          <a:xfrm flipH="1">
            <a:off x="3695582" y="2995994"/>
            <a:ext cx="634255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7" name="TextBox 186">
            <a:extLst>
              <a:ext uri="{FF2B5EF4-FFF2-40B4-BE49-F238E27FC236}">
                <a16:creationId xmlns:a16="http://schemas.microsoft.com/office/drawing/2014/main" id="{3FD12E9E-C8C7-2208-BC99-105AFC9A9098}"/>
              </a:ext>
            </a:extLst>
          </p:cNvPr>
          <p:cNvSpPr txBox="1"/>
          <p:nvPr/>
        </p:nvSpPr>
        <p:spPr>
          <a:xfrm>
            <a:off x="2580069" y="3895614"/>
            <a:ext cx="1167101" cy="8771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75" b="1" dirty="0">
                <a:solidFill>
                  <a:srgbClr val="009051"/>
                </a:solidFill>
              </a:rPr>
              <a:t>DIA search</a:t>
            </a:r>
          </a:p>
          <a:p>
            <a:pPr algn="ctr"/>
            <a:r>
              <a:rPr lang="en-US" sz="1275" b="1" dirty="0">
                <a:solidFill>
                  <a:srgbClr val="009051"/>
                </a:solidFill>
              </a:rPr>
              <a:t>of deep</a:t>
            </a:r>
          </a:p>
          <a:p>
            <a:pPr algn="ctr"/>
            <a:r>
              <a:rPr lang="en-US" sz="1275" b="1" dirty="0">
                <a:solidFill>
                  <a:srgbClr val="009051"/>
                </a:solidFill>
              </a:rPr>
              <a:t>spectral library</a:t>
            </a:r>
          </a:p>
        </p:txBody>
      </p:sp>
      <p:cxnSp>
        <p:nvCxnSpPr>
          <p:cNvPr id="188" name="Straight Arrow Connector 187">
            <a:extLst>
              <a:ext uri="{FF2B5EF4-FFF2-40B4-BE49-F238E27FC236}">
                <a16:creationId xmlns:a16="http://schemas.microsoft.com/office/drawing/2014/main" id="{908AA73A-82D0-11E3-BDAF-21B9B5549D2F}"/>
              </a:ext>
            </a:extLst>
          </p:cNvPr>
          <p:cNvCxnSpPr>
            <a:cxnSpLocks/>
          </p:cNvCxnSpPr>
          <p:nvPr/>
        </p:nvCxnSpPr>
        <p:spPr>
          <a:xfrm flipH="1">
            <a:off x="3695582" y="4208991"/>
            <a:ext cx="634255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9" name="Straight Connector 188">
            <a:extLst>
              <a:ext uri="{FF2B5EF4-FFF2-40B4-BE49-F238E27FC236}">
                <a16:creationId xmlns:a16="http://schemas.microsoft.com/office/drawing/2014/main" id="{76831B08-3829-CC97-3184-A8F167C1829E}"/>
              </a:ext>
            </a:extLst>
          </p:cNvPr>
          <p:cNvCxnSpPr/>
          <p:nvPr/>
        </p:nvCxnSpPr>
        <p:spPr>
          <a:xfrm>
            <a:off x="5321864" y="3895613"/>
            <a:ext cx="836792" cy="0"/>
          </a:xfrm>
          <a:prstGeom prst="line">
            <a:avLst/>
          </a:prstGeom>
          <a:ln w="19050"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0" name="Straight Connector 189">
            <a:extLst>
              <a:ext uri="{FF2B5EF4-FFF2-40B4-BE49-F238E27FC236}">
                <a16:creationId xmlns:a16="http://schemas.microsoft.com/office/drawing/2014/main" id="{F7CE9E56-A911-C429-C422-6E02938FC6FC}"/>
              </a:ext>
            </a:extLst>
          </p:cNvPr>
          <p:cNvCxnSpPr/>
          <p:nvPr/>
        </p:nvCxnSpPr>
        <p:spPr>
          <a:xfrm>
            <a:off x="5320188" y="4485295"/>
            <a:ext cx="836792" cy="0"/>
          </a:xfrm>
          <a:prstGeom prst="line">
            <a:avLst/>
          </a:prstGeom>
          <a:ln w="19050"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1" name="Straight Arrow Connector 190">
            <a:extLst>
              <a:ext uri="{FF2B5EF4-FFF2-40B4-BE49-F238E27FC236}">
                <a16:creationId xmlns:a16="http://schemas.microsoft.com/office/drawing/2014/main" id="{FFA55E03-5AAB-A0D3-20BE-A95C459F35FC}"/>
              </a:ext>
            </a:extLst>
          </p:cNvPr>
          <p:cNvCxnSpPr>
            <a:stCxn id="187" idx="0"/>
            <a:endCxn id="155" idx="2"/>
          </p:cNvCxnSpPr>
          <p:nvPr/>
        </p:nvCxnSpPr>
        <p:spPr>
          <a:xfrm flipV="1">
            <a:off x="3163620" y="3372829"/>
            <a:ext cx="0" cy="522785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2" name="TextBox 191">
            <a:extLst>
              <a:ext uri="{FF2B5EF4-FFF2-40B4-BE49-F238E27FC236}">
                <a16:creationId xmlns:a16="http://schemas.microsoft.com/office/drawing/2014/main" id="{B64A95A7-C6C3-DE28-0F14-BBF306C344E4}"/>
              </a:ext>
            </a:extLst>
          </p:cNvPr>
          <p:cNvSpPr txBox="1"/>
          <p:nvPr/>
        </p:nvSpPr>
        <p:spPr>
          <a:xfrm>
            <a:off x="4640125" y="2878159"/>
            <a:ext cx="485389" cy="2885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75" b="1" dirty="0">
                <a:solidFill>
                  <a:srgbClr val="0432FF"/>
                </a:solidFill>
              </a:rPr>
              <a:t>DDA</a:t>
            </a:r>
          </a:p>
        </p:txBody>
      </p:sp>
      <p:sp>
        <p:nvSpPr>
          <p:cNvPr id="193" name="TextBox 192">
            <a:extLst>
              <a:ext uri="{FF2B5EF4-FFF2-40B4-BE49-F238E27FC236}">
                <a16:creationId xmlns:a16="http://schemas.microsoft.com/office/drawing/2014/main" id="{B2C5555D-0717-3AFA-A3D2-8CFA96B8FFB3}"/>
              </a:ext>
            </a:extLst>
          </p:cNvPr>
          <p:cNvSpPr txBox="1"/>
          <p:nvPr/>
        </p:nvSpPr>
        <p:spPr>
          <a:xfrm>
            <a:off x="4640124" y="3475689"/>
            <a:ext cx="429926" cy="2885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75" b="1" dirty="0">
                <a:solidFill>
                  <a:srgbClr val="009051"/>
                </a:solidFill>
              </a:rPr>
              <a:t>DIA</a:t>
            </a:r>
          </a:p>
        </p:txBody>
      </p:sp>
      <p:sp>
        <p:nvSpPr>
          <p:cNvPr id="194" name="TextBox 193">
            <a:extLst>
              <a:ext uri="{FF2B5EF4-FFF2-40B4-BE49-F238E27FC236}">
                <a16:creationId xmlns:a16="http://schemas.microsoft.com/office/drawing/2014/main" id="{27961EE3-B941-7263-2EE8-FC9DBF7D81EF}"/>
              </a:ext>
            </a:extLst>
          </p:cNvPr>
          <p:cNvSpPr txBox="1"/>
          <p:nvPr/>
        </p:nvSpPr>
        <p:spPr>
          <a:xfrm>
            <a:off x="4640124" y="4690841"/>
            <a:ext cx="429926" cy="2885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75" b="1" dirty="0">
                <a:solidFill>
                  <a:srgbClr val="009051"/>
                </a:solidFill>
              </a:rPr>
              <a:t>DIA</a:t>
            </a:r>
          </a:p>
        </p:txBody>
      </p:sp>
      <p:sp>
        <p:nvSpPr>
          <p:cNvPr id="195" name="TextBox 194">
            <a:extLst>
              <a:ext uri="{FF2B5EF4-FFF2-40B4-BE49-F238E27FC236}">
                <a16:creationId xmlns:a16="http://schemas.microsoft.com/office/drawing/2014/main" id="{D09C68F0-79E2-A615-86B8-594EE2A0141F}"/>
              </a:ext>
            </a:extLst>
          </p:cNvPr>
          <p:cNvSpPr txBox="1"/>
          <p:nvPr/>
        </p:nvSpPr>
        <p:spPr>
          <a:xfrm>
            <a:off x="4640124" y="4063449"/>
            <a:ext cx="429926" cy="2885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75" b="1" dirty="0">
                <a:solidFill>
                  <a:srgbClr val="009051"/>
                </a:solidFill>
              </a:rPr>
              <a:t>DIA</a:t>
            </a:r>
          </a:p>
        </p:txBody>
      </p:sp>
      <p:sp>
        <p:nvSpPr>
          <p:cNvPr id="196" name="Left Brace 195">
            <a:extLst>
              <a:ext uri="{FF2B5EF4-FFF2-40B4-BE49-F238E27FC236}">
                <a16:creationId xmlns:a16="http://schemas.microsoft.com/office/drawing/2014/main" id="{3B9973A8-EE90-8DA3-3C9B-67EF9E73031E}"/>
              </a:ext>
            </a:extLst>
          </p:cNvPr>
          <p:cNvSpPr/>
          <p:nvPr/>
        </p:nvSpPr>
        <p:spPr>
          <a:xfrm>
            <a:off x="4353302" y="3298733"/>
            <a:ext cx="229233" cy="1818243"/>
          </a:xfrm>
          <a:prstGeom prst="leftBrac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275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AC95315-6754-C12B-0FA8-46A2046D06AD}"/>
              </a:ext>
            </a:extLst>
          </p:cNvPr>
          <p:cNvSpPr txBox="1"/>
          <p:nvPr/>
        </p:nvSpPr>
        <p:spPr>
          <a:xfrm>
            <a:off x="281806" y="426720"/>
            <a:ext cx="12289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-04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E300AC8-15BD-7AC2-7C6D-BEBC6B60FE12}"/>
              </a:ext>
            </a:extLst>
          </p:cNvPr>
          <p:cNvSpPr txBox="1"/>
          <p:nvPr/>
        </p:nvSpPr>
        <p:spPr>
          <a:xfrm>
            <a:off x="495621" y="6746395"/>
            <a:ext cx="6893605" cy="295068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4 Fig. Simplified proteomic workflow. 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cheme of the sample preparation, data collection, and data processing for the DDA data collected using a 120-min microflow gradient to build a custom deep spectral library and for the DIA data acquired using a 20-, 45-, or 120-min microflow gradient to identify peptides and proteins by searching against the deep spectral library for accurate quantification.</a:t>
            </a:r>
            <a:endParaRPr lang="en-U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8533722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17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17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17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17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3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5" dur="500" fill="hold"/>
                                        <p:tgtEl>
                                          <p:spTgt spid="170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170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7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9" dur="500" fill="hold"/>
                                        <p:tgtEl>
                                          <p:spTgt spid="17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0" dur="500" fill="hold"/>
                                        <p:tgtEl>
                                          <p:spTgt spid="17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21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3" dur="500" fill="hold"/>
                                        <p:tgtEl>
                                          <p:spTgt spid="19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4" dur="500" fill="hold"/>
                                        <p:tgtEl>
                                          <p:spTgt spid="19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25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7" dur="500" fill="hold"/>
                                        <p:tgtEl>
                                          <p:spTgt spid="186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8" dur="500" fill="hold"/>
                                        <p:tgtEl>
                                          <p:spTgt spid="186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29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31" dur="500" fill="hold"/>
                                        <p:tgtEl>
                                          <p:spTgt spid="155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32" dur="500" fill="hold"/>
                                        <p:tgtEl>
                                          <p:spTgt spid="155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33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35" dur="500" fill="hold"/>
                                        <p:tgtEl>
                                          <p:spTgt spid="15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36" dur="500" fill="hold"/>
                                        <p:tgtEl>
                                          <p:spTgt spid="15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37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39" dur="500" fill="hold"/>
                                        <p:tgtEl>
                                          <p:spTgt spid="159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40" dur="500" fill="hold"/>
                                        <p:tgtEl>
                                          <p:spTgt spid="159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41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43" dur="500" fill="hold"/>
                                        <p:tgtEl>
                                          <p:spTgt spid="141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44" dur="500" fill="hold"/>
                                        <p:tgtEl>
                                          <p:spTgt spid="141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45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47" dur="500" fill="hold"/>
                                        <p:tgtEl>
                                          <p:spTgt spid="15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48" dur="500" fill="hold"/>
                                        <p:tgtEl>
                                          <p:spTgt spid="15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49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51" dur="500" fill="hold"/>
                                        <p:tgtEl>
                                          <p:spTgt spid="15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52" dur="500" fill="hold"/>
                                        <p:tgtEl>
                                          <p:spTgt spid="15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3" fill="hold">
                      <p:stCondLst>
                        <p:cond delay="indefinite"/>
                      </p:stCondLst>
                      <p:childTnLst>
                        <p:par>
                          <p:cTn id="54" fill="hold">
                            <p:stCondLst>
                              <p:cond delay="0"/>
                            </p:stCondLst>
                            <p:childTnLst>
                              <p:par>
                                <p:cTn id="55" presetID="2" presetClass="entr" presetSubtype="4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57" dur="500" fill="hold"/>
                                        <p:tgtEl>
                                          <p:spTgt spid="173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58" dur="500" fill="hold"/>
                                        <p:tgtEl>
                                          <p:spTgt spid="173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59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61" dur="500" fill="hold"/>
                                        <p:tgtEl>
                                          <p:spTgt spid="17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62" dur="500" fill="hold"/>
                                        <p:tgtEl>
                                          <p:spTgt spid="17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63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65" dur="500" fill="hold"/>
                                        <p:tgtEl>
                                          <p:spTgt spid="175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66" dur="500" fill="hold"/>
                                        <p:tgtEl>
                                          <p:spTgt spid="175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67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69" dur="500" fill="hold"/>
                                        <p:tgtEl>
                                          <p:spTgt spid="171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70" dur="500" fill="hold"/>
                                        <p:tgtEl>
                                          <p:spTgt spid="171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71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3" dur="500" fill="hold"/>
                                        <p:tgtEl>
                                          <p:spTgt spid="176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74" dur="500" fill="hold"/>
                                        <p:tgtEl>
                                          <p:spTgt spid="176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75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7" dur="500" fill="hold"/>
                                        <p:tgtEl>
                                          <p:spTgt spid="179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78" dur="500" fill="hold"/>
                                        <p:tgtEl>
                                          <p:spTgt spid="179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79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81" dur="500" fill="hold"/>
                                        <p:tgtEl>
                                          <p:spTgt spid="180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2" dur="500" fill="hold"/>
                                        <p:tgtEl>
                                          <p:spTgt spid="180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83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85" dur="500" fill="hold"/>
                                        <p:tgtEl>
                                          <p:spTgt spid="181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6" dur="500" fill="hold"/>
                                        <p:tgtEl>
                                          <p:spTgt spid="181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87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89" dur="500" fill="hold"/>
                                        <p:tgtEl>
                                          <p:spTgt spid="18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90" dur="500" fill="hold"/>
                                        <p:tgtEl>
                                          <p:spTgt spid="18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1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93" dur="500" fill="hold"/>
                                        <p:tgtEl>
                                          <p:spTgt spid="183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94" dur="500" fill="hold"/>
                                        <p:tgtEl>
                                          <p:spTgt spid="183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5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97" dur="500" fill="hold"/>
                                        <p:tgtEl>
                                          <p:spTgt spid="18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98" dur="500" fill="hold"/>
                                        <p:tgtEl>
                                          <p:spTgt spid="18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9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01" dur="500" fill="hold"/>
                                        <p:tgtEl>
                                          <p:spTgt spid="189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02" dur="500" fill="hold"/>
                                        <p:tgtEl>
                                          <p:spTgt spid="189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03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05" dur="500" fill="hold"/>
                                        <p:tgtEl>
                                          <p:spTgt spid="190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06" dur="500" fill="hold"/>
                                        <p:tgtEl>
                                          <p:spTgt spid="190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07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09" dur="500" fill="hold"/>
                                        <p:tgtEl>
                                          <p:spTgt spid="185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10" dur="500" fill="hold"/>
                                        <p:tgtEl>
                                          <p:spTgt spid="185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11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3" dur="500" fill="hold"/>
                                        <p:tgtEl>
                                          <p:spTgt spid="169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14" dur="500" fill="hold"/>
                                        <p:tgtEl>
                                          <p:spTgt spid="169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15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7" dur="500" fill="hold"/>
                                        <p:tgtEl>
                                          <p:spTgt spid="193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18" dur="500" fill="hold"/>
                                        <p:tgtEl>
                                          <p:spTgt spid="193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19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21" dur="500" fill="hold"/>
                                        <p:tgtEl>
                                          <p:spTgt spid="195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2" dur="500" fill="hold"/>
                                        <p:tgtEl>
                                          <p:spTgt spid="195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23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25" dur="500" fill="hold"/>
                                        <p:tgtEl>
                                          <p:spTgt spid="19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6" dur="500" fill="hold"/>
                                        <p:tgtEl>
                                          <p:spTgt spid="19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27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29" dur="500" fill="hold"/>
                                        <p:tgtEl>
                                          <p:spTgt spid="196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30" dur="500" fill="hold"/>
                                        <p:tgtEl>
                                          <p:spTgt spid="196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31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33" dur="500" fill="hold"/>
                                        <p:tgtEl>
                                          <p:spTgt spid="18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34" dur="500" fill="hold"/>
                                        <p:tgtEl>
                                          <p:spTgt spid="18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35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37" dur="500" fill="hold"/>
                                        <p:tgtEl>
                                          <p:spTgt spid="18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38" dur="500" fill="hold"/>
                                        <p:tgtEl>
                                          <p:spTgt spid="18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39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41" dur="500" fill="hold"/>
                                        <p:tgtEl>
                                          <p:spTgt spid="191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42" dur="500" fill="hold"/>
                                        <p:tgtEl>
                                          <p:spTgt spid="191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54" grpId="0"/>
      <p:bldP spid="155" grpId="0"/>
      <p:bldP spid="157" grpId="0" animBg="1"/>
      <p:bldP spid="158" grpId="0" animBg="1"/>
      <p:bldP spid="159" grpId="0"/>
      <p:bldP spid="169" grpId="0"/>
      <p:bldP spid="170" grpId="0"/>
      <p:bldP spid="172" grpId="0"/>
      <p:bldP spid="177" grpId="0" animBg="1"/>
      <p:bldP spid="178" grpId="0"/>
      <p:bldP spid="179" grpId="0"/>
      <p:bldP spid="182" grpId="0"/>
      <p:bldP spid="183" grpId="0"/>
      <p:bldP spid="184" grpId="0"/>
      <p:bldP spid="185" grpId="0" animBg="1"/>
      <p:bldP spid="187" grpId="0"/>
      <p:bldP spid="192" grpId="0"/>
      <p:bldP spid="193" grpId="0"/>
      <p:bldP spid="194" grpId="0"/>
      <p:bldP spid="195" grpId="0"/>
      <p:bldP spid="196" grpId="0" animBg="1"/>
    </p:bld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473</TotalTime>
  <Words>180</Words>
  <Application>Microsoft Macintosh PowerPoint</Application>
  <PresentationFormat>Custom</PresentationFormat>
  <Paragraphs>4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ain Figures</dc:title>
  <dc:creator>Jordan Burton</dc:creator>
  <cp:lastModifiedBy>Jordan Burton</cp:lastModifiedBy>
  <cp:revision>40</cp:revision>
  <cp:lastPrinted>2022-06-23T21:58:45Z</cp:lastPrinted>
  <dcterms:created xsi:type="dcterms:W3CDTF">2022-06-13T21:49:24Z</dcterms:created>
  <dcterms:modified xsi:type="dcterms:W3CDTF">2023-02-25T01:05:24Z</dcterms:modified>
</cp:coreProperties>
</file>